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12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FACS-result-&#53685;&#54633;.xlsx" TargetMode="Externa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FACS-result-&#53685;&#54633;.xlsx" TargetMode="Externa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istrator\Desktop\FACS-result-&#53685;&#54633;.xlsx" TargetMode="Externa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Asynchronize</a:t>
            </a:r>
            <a:endParaRPr lang="ko-KR" altLang="en-US" sz="1200"/>
          </a:p>
        </c:rich>
      </c:tx>
      <c:layout/>
    </c:title>
    <c:plotArea>
      <c:layout>
        <c:manualLayout>
          <c:layoutTarget val="inner"/>
          <c:xMode val="edge"/>
          <c:yMode val="edge"/>
          <c:x val="0.16293525809273879"/>
          <c:y val="0.22933864915572244"/>
          <c:w val="0.74522572178477764"/>
          <c:h val="0.60485146966854486"/>
        </c:manualLayout>
      </c:layout>
      <c:barChart>
        <c:barDir val="bar"/>
        <c:grouping val="stacked"/>
        <c:ser>
          <c:idx val="0"/>
          <c:order val="0"/>
          <c:tx>
            <c:strRef>
              <c:f>Asynch!$R$2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</c:spPr>
          <c:errBars>
            <c:errBarType val="both"/>
            <c:errValType val="cust"/>
            <c:plus>
              <c:numRef>
                <c:f>Asynch!$Q$8:$Q$11</c:f>
                <c:numCache>
                  <c:formatCode>General</c:formatCode>
                  <c:ptCount val="4"/>
                  <c:pt idx="0">
                    <c:v>3.1581059724672582</c:v>
                  </c:pt>
                  <c:pt idx="1">
                    <c:v>3.7368982235716692</c:v>
                  </c:pt>
                  <c:pt idx="2">
                    <c:v>3.4797255040208843</c:v>
                  </c:pt>
                  <c:pt idx="3">
                    <c:v>2.4040707664293199</c:v>
                  </c:pt>
                </c:numCache>
              </c:numRef>
            </c:plus>
            <c:minus>
              <c:numRef>
                <c:f>Asynch!$Q$8:$Q$11</c:f>
                <c:numCache>
                  <c:formatCode>General</c:formatCode>
                  <c:ptCount val="4"/>
                  <c:pt idx="0">
                    <c:v>3.1581059724672582</c:v>
                  </c:pt>
                  <c:pt idx="1">
                    <c:v>3.7368982235716692</c:v>
                  </c:pt>
                  <c:pt idx="2">
                    <c:v>3.4797255040208843</c:v>
                  </c:pt>
                  <c:pt idx="3">
                    <c:v>2.4040707664293199</c:v>
                  </c:pt>
                </c:numCache>
              </c:numRef>
            </c:minus>
          </c:errBars>
          <c:cat>
            <c:strRef>
              <c:f>Asynch!$Q$3:$Q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Asynch!$R$3:$R$6</c:f>
              <c:numCache>
                <c:formatCode>General</c:formatCode>
                <c:ptCount val="4"/>
                <c:pt idx="0">
                  <c:v>46.448300000000003</c:v>
                </c:pt>
                <c:pt idx="1">
                  <c:v>48.235000000000049</c:v>
                </c:pt>
                <c:pt idx="2">
                  <c:v>48.423500000000011</c:v>
                </c:pt>
                <c:pt idx="3">
                  <c:v>51.980000000000004</c:v>
                </c:pt>
              </c:numCache>
            </c:numRef>
          </c:val>
        </c:ser>
        <c:ser>
          <c:idx val="1"/>
          <c:order val="1"/>
          <c:tx>
            <c:strRef>
              <c:f>Asynch!$S$2</c:f>
              <c:strCache>
                <c:ptCount val="1"/>
                <c:pt idx="0">
                  <c:v>S</c:v>
                </c:pt>
              </c:strCache>
            </c:strRef>
          </c:tx>
          <c:spPr>
            <a:blipFill>
              <a:blip xmlns:r="http://schemas.openxmlformats.org/officeDocument/2006/relationships" r:embed="rId1"/>
              <a:stretch>
                <a:fillRect/>
              </a:stretch>
            </a:blipFill>
            <a:ln>
              <a:solidFill>
                <a:prstClr val="white">
                  <a:lumMod val="50000"/>
                </a:prstClr>
              </a:solidFill>
            </a:ln>
          </c:spPr>
          <c:pictureOptions>
            <c:pictureFormat val="stack"/>
          </c:pictureOptions>
          <c:errBars>
            <c:errBarType val="both"/>
            <c:errValType val="cust"/>
            <c:plus>
              <c:numRef>
                <c:f>Asynch!$R$8:$R$11</c:f>
                <c:numCache>
                  <c:formatCode>General</c:formatCode>
                  <c:ptCount val="4"/>
                  <c:pt idx="0">
                    <c:v>1.9131954073399475</c:v>
                  </c:pt>
                  <c:pt idx="1">
                    <c:v>0.45899346400575208</c:v>
                  </c:pt>
                  <c:pt idx="2">
                    <c:v>0.2275000000000035</c:v>
                  </c:pt>
                  <c:pt idx="3">
                    <c:v>1.8962083878097322</c:v>
                  </c:pt>
                </c:numCache>
              </c:numRef>
            </c:plus>
            <c:minus>
              <c:numRef>
                <c:f>Asynch!$R$8:$R$11</c:f>
                <c:numCache>
                  <c:formatCode>General</c:formatCode>
                  <c:ptCount val="4"/>
                  <c:pt idx="0">
                    <c:v>1.9131954073399475</c:v>
                  </c:pt>
                  <c:pt idx="1">
                    <c:v>0.45899346400575208</c:v>
                  </c:pt>
                  <c:pt idx="2">
                    <c:v>0.2275000000000035</c:v>
                  </c:pt>
                  <c:pt idx="3">
                    <c:v>1.8962083878097322</c:v>
                  </c:pt>
                </c:numCache>
              </c:numRef>
            </c:minus>
          </c:errBars>
          <c:cat>
            <c:strRef>
              <c:f>Asynch!$Q$3:$Q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Asynch!$S$3:$S$6</c:f>
              <c:numCache>
                <c:formatCode>General</c:formatCode>
                <c:ptCount val="4"/>
                <c:pt idx="0">
                  <c:v>29.228299999999972</c:v>
                </c:pt>
                <c:pt idx="1">
                  <c:v>28.124999999999996</c:v>
                </c:pt>
                <c:pt idx="2">
                  <c:v>27.70349999999997</c:v>
                </c:pt>
                <c:pt idx="3">
                  <c:v>27.195</c:v>
                </c:pt>
              </c:numCache>
            </c:numRef>
          </c:val>
        </c:ser>
        <c:ser>
          <c:idx val="2"/>
          <c:order val="2"/>
          <c:tx>
            <c:strRef>
              <c:f>Asynch!$T$2</c:f>
              <c:strCache>
                <c:ptCount val="1"/>
                <c:pt idx="0">
                  <c:v>G2/M</c:v>
                </c:pt>
              </c:strCache>
            </c:strRef>
          </c:tx>
          <c:spPr>
            <a:blipFill>
              <a:blip xmlns:r="http://schemas.openxmlformats.org/officeDocument/2006/relationships" r:embed="rId2"/>
              <a:stretch>
                <a:fillRect/>
              </a:stretch>
            </a:blipFill>
          </c:spPr>
          <c:pictureOptions>
            <c:pictureFormat val="stack"/>
          </c:pictureOptions>
          <c:errBars>
            <c:errBarType val="both"/>
            <c:errValType val="cust"/>
            <c:plus>
              <c:numRef>
                <c:f>Asynch!$S$8:$S$11</c:f>
                <c:numCache>
                  <c:formatCode>General</c:formatCode>
                  <c:ptCount val="4"/>
                  <c:pt idx="0">
                    <c:v>3.1552192211213081</c:v>
                  </c:pt>
                  <c:pt idx="1">
                    <c:v>4.0844216236818633</c:v>
                  </c:pt>
                  <c:pt idx="2">
                    <c:v>4.2810055282997856</c:v>
                  </c:pt>
                  <c:pt idx="3">
                    <c:v>3.7456872422382892</c:v>
                  </c:pt>
                </c:numCache>
              </c:numRef>
            </c:plus>
            <c:minus>
              <c:numRef>
                <c:f>Asynch!$S$8:$S$11</c:f>
                <c:numCache>
                  <c:formatCode>General</c:formatCode>
                  <c:ptCount val="4"/>
                  <c:pt idx="0">
                    <c:v>3.1552192211213081</c:v>
                  </c:pt>
                  <c:pt idx="1">
                    <c:v>4.0844216236818633</c:v>
                  </c:pt>
                  <c:pt idx="2">
                    <c:v>4.2810055282997856</c:v>
                  </c:pt>
                  <c:pt idx="3">
                    <c:v>3.7456872422382892</c:v>
                  </c:pt>
                </c:numCache>
              </c:numRef>
            </c:minus>
          </c:errBars>
          <c:cat>
            <c:strRef>
              <c:f>Asynch!$Q$3:$Q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Asynch!$T$3:$T$6</c:f>
              <c:numCache>
                <c:formatCode>General</c:formatCode>
                <c:ptCount val="4"/>
                <c:pt idx="0">
                  <c:v>24.3233</c:v>
                </c:pt>
                <c:pt idx="1">
                  <c:v>23.64</c:v>
                </c:pt>
                <c:pt idx="2">
                  <c:v>23.871000000000024</c:v>
                </c:pt>
                <c:pt idx="3">
                  <c:v>20.824999999999999</c:v>
                </c:pt>
              </c:numCache>
            </c:numRef>
          </c:val>
        </c:ser>
        <c:gapWidth val="55"/>
        <c:overlap val="100"/>
        <c:axId val="73464832"/>
        <c:axId val="68690688"/>
      </c:barChart>
      <c:catAx>
        <c:axId val="73464832"/>
        <c:scaling>
          <c:orientation val="minMax"/>
        </c:scaling>
        <c:axPos val="l"/>
        <c:tickLblPos val="nextTo"/>
        <c:txPr>
          <a:bodyPr/>
          <a:lstStyle/>
          <a:p>
            <a:pPr>
              <a:defRPr sz="1100" b="1"/>
            </a:pPr>
            <a:endParaRPr lang="ko-KR"/>
          </a:p>
        </c:txPr>
        <c:crossAx val="68690688"/>
        <c:crosses val="autoZero"/>
        <c:auto val="1"/>
        <c:lblAlgn val="ctr"/>
        <c:lblOffset val="100"/>
      </c:catAx>
      <c:valAx>
        <c:axId val="68690688"/>
        <c:scaling>
          <c:orientation val="minMax"/>
          <c:max val="110"/>
          <c:min val="0"/>
        </c:scaling>
        <c:axPos val="b"/>
        <c:majorGridlines/>
        <c:numFmt formatCode="General" sourceLinked="1"/>
        <c:tickLblPos val="nextTo"/>
        <c:crossAx val="73464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7811666666666666"/>
          <c:y val="0.39873775276214302"/>
          <c:w val="0.12188333333333333"/>
          <c:h val="0.35905722326454126"/>
        </c:manualLayout>
      </c:layout>
      <c:txPr>
        <a:bodyPr/>
        <a:lstStyle/>
        <a:p>
          <a:pPr>
            <a:defRPr b="1"/>
          </a:pPr>
          <a:endParaRPr lang="ko-KR"/>
        </a:p>
      </c:txPr>
    </c:legend>
    <c:plotVisOnly val="1"/>
  </c:chart>
  <c:externalData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Thymidine release 0</a:t>
            </a:r>
            <a:r>
              <a:rPr lang="en-US" altLang="ko-KR" sz="1200" baseline="0"/>
              <a:t> h</a:t>
            </a:r>
            <a:endParaRPr lang="ko-KR" altLang="en-US" sz="1200"/>
          </a:p>
        </c:rich>
      </c:tx>
      <c:layout>
        <c:manualLayout>
          <c:xMode val="edge"/>
          <c:yMode val="edge"/>
          <c:x val="0.30229004629629624"/>
          <c:y val="3.9712320200125079E-2"/>
        </c:manualLayout>
      </c:layout>
    </c:title>
    <c:plotArea>
      <c:layout>
        <c:manualLayout>
          <c:layoutTarget val="inner"/>
          <c:xMode val="edge"/>
          <c:yMode val="edge"/>
          <c:x val="0.16293525809273876"/>
          <c:y val="0.22933864915572241"/>
          <c:w val="0.74244794400699921"/>
          <c:h val="0.60485146966854486"/>
        </c:manualLayout>
      </c:layout>
      <c:barChart>
        <c:barDir val="bar"/>
        <c:grouping val="stacked"/>
        <c:ser>
          <c:idx val="0"/>
          <c:order val="0"/>
          <c:tx>
            <c:strRef>
              <c:f>'Thymidine-0h'!$P$2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prstClr val="black">
                <a:lumMod val="75000"/>
                <a:lumOff val="25000"/>
              </a:prstClr>
            </a:solidFill>
          </c:spPr>
          <c:errBars>
            <c:errBarType val="both"/>
            <c:errValType val="cust"/>
            <c:plus>
              <c:numRef>
                <c:f>'Thymidine-0h'!$P$8:$P$11</c:f>
                <c:numCache>
                  <c:formatCode>General</c:formatCode>
                  <c:ptCount val="4"/>
                  <c:pt idx="0">
                    <c:v>2.3648431942379027</c:v>
                  </c:pt>
                  <c:pt idx="1">
                    <c:v>2.7764677049565449</c:v>
                  </c:pt>
                  <c:pt idx="2">
                    <c:v>3.1599498941175197</c:v>
                  </c:pt>
                  <c:pt idx="3">
                    <c:v>3.9204655335814387</c:v>
                  </c:pt>
                </c:numCache>
              </c:numRef>
            </c:plus>
            <c:minus>
              <c:numRef>
                <c:f>'Thymidine-0h'!$P$8:$P$11</c:f>
                <c:numCache>
                  <c:formatCode>General</c:formatCode>
                  <c:ptCount val="4"/>
                  <c:pt idx="0">
                    <c:v>2.3648431942379027</c:v>
                  </c:pt>
                  <c:pt idx="1">
                    <c:v>2.7764677049565449</c:v>
                  </c:pt>
                  <c:pt idx="2">
                    <c:v>3.1599498941175197</c:v>
                  </c:pt>
                  <c:pt idx="3">
                    <c:v>3.9204655335814387</c:v>
                  </c:pt>
                </c:numCache>
              </c:numRef>
            </c:minus>
          </c:errBars>
          <c:cat>
            <c:strRef>
              <c:f>'Thymidine-0h'!$O$3:$O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'Thymidine-0h'!$P$3:$P$6</c:f>
              <c:numCache>
                <c:formatCode>General</c:formatCode>
                <c:ptCount val="4"/>
                <c:pt idx="0">
                  <c:v>16.820800000000023</c:v>
                </c:pt>
                <c:pt idx="1">
                  <c:v>16.697499999999987</c:v>
                </c:pt>
                <c:pt idx="2">
                  <c:v>17.355799999999974</c:v>
                </c:pt>
                <c:pt idx="3">
                  <c:v>19.218</c:v>
                </c:pt>
              </c:numCache>
            </c:numRef>
          </c:val>
        </c:ser>
        <c:ser>
          <c:idx val="1"/>
          <c:order val="1"/>
          <c:tx>
            <c:strRef>
              <c:f>'Thymidine-0h'!$Q$2</c:f>
              <c:strCache>
                <c:ptCount val="1"/>
                <c:pt idx="0">
                  <c:v>S</c:v>
                </c:pt>
              </c:strCache>
            </c:strRef>
          </c:tx>
          <c:spPr>
            <a:blipFill>
              <a:blip xmlns:r="http://schemas.openxmlformats.org/officeDocument/2006/relationships" r:embed="rId1"/>
              <a:stretch>
                <a:fillRect/>
              </a:stretch>
            </a:blipFill>
            <a:ln>
              <a:solidFill>
                <a:prstClr val="white">
                  <a:lumMod val="50000"/>
                </a:prstClr>
              </a:solidFill>
            </a:ln>
          </c:spPr>
          <c:pictureOptions>
            <c:pictureFormat val="stack"/>
          </c:pictureOptions>
          <c:errBars>
            <c:errBarType val="both"/>
            <c:errValType val="cust"/>
            <c:plus>
              <c:numRef>
                <c:f>'Thymidine-0h'!$Q$8:$Q$11</c:f>
                <c:numCache>
                  <c:formatCode>General</c:formatCode>
                  <c:ptCount val="4"/>
                  <c:pt idx="0">
                    <c:v>5.3576944279543577</c:v>
                  </c:pt>
                  <c:pt idx="1">
                    <c:v>6.4568761797017729</c:v>
                  </c:pt>
                  <c:pt idx="2">
                    <c:v>5.7201821066582559</c:v>
                  </c:pt>
                  <c:pt idx="3">
                    <c:v>4.8261378192090385</c:v>
                  </c:pt>
                </c:numCache>
              </c:numRef>
            </c:plus>
            <c:minus>
              <c:numRef>
                <c:f>'Thymidine-0h'!$Q$8:$Q$11</c:f>
                <c:numCache>
                  <c:formatCode>General</c:formatCode>
                  <c:ptCount val="4"/>
                  <c:pt idx="0">
                    <c:v>5.3576944279543577</c:v>
                  </c:pt>
                  <c:pt idx="1">
                    <c:v>6.4568761797017729</c:v>
                  </c:pt>
                  <c:pt idx="2">
                    <c:v>5.7201821066582559</c:v>
                  </c:pt>
                  <c:pt idx="3">
                    <c:v>4.8261378192090385</c:v>
                  </c:pt>
                </c:numCache>
              </c:numRef>
            </c:minus>
          </c:errBars>
          <c:cat>
            <c:strRef>
              <c:f>'Thymidine-0h'!$O$3:$O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'Thymidine-0h'!$Q$3:$Q$6</c:f>
              <c:numCache>
                <c:formatCode>General</c:formatCode>
                <c:ptCount val="4"/>
                <c:pt idx="0">
                  <c:v>57.028300000000058</c:v>
                </c:pt>
                <c:pt idx="1">
                  <c:v>58.375</c:v>
                </c:pt>
                <c:pt idx="2">
                  <c:v>57.6158</c:v>
                </c:pt>
                <c:pt idx="3">
                  <c:v>55.270500000000013</c:v>
                </c:pt>
              </c:numCache>
            </c:numRef>
          </c:val>
        </c:ser>
        <c:ser>
          <c:idx val="2"/>
          <c:order val="2"/>
          <c:tx>
            <c:strRef>
              <c:f>'Thymidine-0h'!$R$2</c:f>
              <c:strCache>
                <c:ptCount val="1"/>
                <c:pt idx="0">
                  <c:v>G2/M</c:v>
                </c:pt>
              </c:strCache>
            </c:strRef>
          </c:tx>
          <c:spPr>
            <a:blipFill>
              <a:blip xmlns:r="http://schemas.openxmlformats.org/officeDocument/2006/relationships" r:embed="rId2"/>
              <a:stretch>
                <a:fillRect/>
              </a:stretch>
            </a:blipFill>
          </c:spPr>
          <c:pictureOptions>
            <c:pictureFormat val="stack"/>
          </c:pictureOptions>
          <c:errBars>
            <c:errBarType val="both"/>
            <c:errValType val="cust"/>
            <c:plus>
              <c:numRef>
                <c:f>'Thymidine-0h'!$R$8:$R$11</c:f>
                <c:numCache>
                  <c:formatCode>General</c:formatCode>
                  <c:ptCount val="4"/>
                  <c:pt idx="0">
                    <c:v>2.140696927015445</c:v>
                  </c:pt>
                  <c:pt idx="1">
                    <c:v>2.8297714130296785</c:v>
                  </c:pt>
                  <c:pt idx="2">
                    <c:v>4.2061430768975692</c:v>
                  </c:pt>
                  <c:pt idx="3">
                    <c:v>3.7088416318306199</c:v>
                  </c:pt>
                </c:numCache>
              </c:numRef>
            </c:plus>
            <c:minus>
              <c:numRef>
                <c:f>'Thymidine-0h'!$R$8:$R$11</c:f>
                <c:numCache>
                  <c:formatCode>General</c:formatCode>
                  <c:ptCount val="4"/>
                  <c:pt idx="0">
                    <c:v>2.140696927015445</c:v>
                  </c:pt>
                  <c:pt idx="1">
                    <c:v>2.8297714130296785</c:v>
                  </c:pt>
                  <c:pt idx="2">
                    <c:v>4.2061430768975692</c:v>
                  </c:pt>
                  <c:pt idx="3">
                    <c:v>3.7088416318306199</c:v>
                  </c:pt>
                </c:numCache>
              </c:numRef>
            </c:minus>
          </c:errBars>
          <c:cat>
            <c:strRef>
              <c:f>'Thymidine-0h'!$O$3:$O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'Thymidine-0h'!$R$3:$R$6</c:f>
              <c:numCache>
                <c:formatCode>General</c:formatCode>
                <c:ptCount val="4"/>
                <c:pt idx="0">
                  <c:v>26.150799999999986</c:v>
                </c:pt>
                <c:pt idx="1">
                  <c:v>24.92749999999997</c:v>
                </c:pt>
                <c:pt idx="2">
                  <c:v>25.028300000000002</c:v>
                </c:pt>
                <c:pt idx="3">
                  <c:v>25.5105</c:v>
                </c:pt>
              </c:numCache>
            </c:numRef>
          </c:val>
        </c:ser>
        <c:gapWidth val="55"/>
        <c:overlap val="100"/>
        <c:axId val="68717568"/>
        <c:axId val="68731648"/>
      </c:barChart>
      <c:catAx>
        <c:axId val="68717568"/>
        <c:scaling>
          <c:orientation val="minMax"/>
        </c:scaling>
        <c:axPos val="l"/>
        <c:tickLblPos val="nextTo"/>
        <c:txPr>
          <a:bodyPr/>
          <a:lstStyle/>
          <a:p>
            <a:pPr>
              <a:defRPr sz="1100" b="1"/>
            </a:pPr>
            <a:endParaRPr lang="ko-KR"/>
          </a:p>
        </c:txPr>
        <c:crossAx val="68731648"/>
        <c:crosses val="autoZero"/>
        <c:auto val="1"/>
        <c:lblAlgn val="ctr"/>
        <c:lblOffset val="100"/>
      </c:catAx>
      <c:valAx>
        <c:axId val="68731648"/>
        <c:scaling>
          <c:orientation val="minMax"/>
          <c:max val="110"/>
          <c:min val="0"/>
        </c:scaling>
        <c:axPos val="b"/>
        <c:majorGridlines/>
        <c:numFmt formatCode="General" sourceLinked="1"/>
        <c:tickLblPos val="nextTo"/>
        <c:crossAx val="687175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7811666666666666"/>
          <c:y val="0.39873775276214302"/>
          <c:w val="0.12188333333333333"/>
          <c:h val="0.35905722326454126"/>
        </c:manualLayout>
      </c:layout>
      <c:txPr>
        <a:bodyPr/>
        <a:lstStyle/>
        <a:p>
          <a:pPr>
            <a:defRPr b="1"/>
          </a:pPr>
          <a:endParaRPr lang="ko-KR"/>
        </a:p>
      </c:txPr>
    </c:legend>
    <c:plotVisOnly val="1"/>
  </c:chart>
  <c:externalData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title>
      <c:tx>
        <c:rich>
          <a:bodyPr/>
          <a:lstStyle/>
          <a:p>
            <a:pPr>
              <a:defRPr sz="1200"/>
            </a:pPr>
            <a:r>
              <a:rPr lang="en-US" altLang="ko-KR" sz="1200"/>
              <a:t>Thymidine release 8 h</a:t>
            </a:r>
            <a:endParaRPr lang="ko-KR" altLang="en-US" sz="1200"/>
          </a:p>
        </c:rich>
      </c:tx>
      <c:layout/>
    </c:title>
    <c:plotArea>
      <c:layout>
        <c:manualLayout>
          <c:layoutTarget val="inner"/>
          <c:xMode val="edge"/>
          <c:yMode val="edge"/>
          <c:x val="0.16293525809273876"/>
          <c:y val="0.22956524733085504"/>
          <c:w val="0.74157305336833013"/>
          <c:h val="0.6044610429515066"/>
        </c:manualLayout>
      </c:layout>
      <c:barChart>
        <c:barDir val="bar"/>
        <c:grouping val="stacked"/>
        <c:ser>
          <c:idx val="0"/>
          <c:order val="0"/>
          <c:tx>
            <c:strRef>
              <c:f>'Thymidine-8h'!$Q$2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prstClr val="black">
                <a:lumMod val="75000"/>
                <a:lumOff val="25000"/>
              </a:prstClr>
            </a:solidFill>
          </c:spPr>
          <c:errBars>
            <c:errBarType val="both"/>
            <c:errValType val="cust"/>
            <c:plus>
              <c:numRef>
                <c:f>'Thymidine-8h'!$Q$8:$Q$11</c:f>
                <c:numCache>
                  <c:formatCode>General</c:formatCode>
                  <c:ptCount val="4"/>
                  <c:pt idx="0">
                    <c:v>1.504600943772135</c:v>
                  </c:pt>
                  <c:pt idx="1">
                    <c:v>2.3193158473998348</c:v>
                  </c:pt>
                  <c:pt idx="2">
                    <c:v>3.3404903831623298</c:v>
                  </c:pt>
                  <c:pt idx="3">
                    <c:v>3.8524688188225467</c:v>
                  </c:pt>
                </c:numCache>
              </c:numRef>
            </c:plus>
            <c:minus>
              <c:numRef>
                <c:f>'Thymidine-8h'!$Q$8:$Q$11</c:f>
                <c:numCache>
                  <c:formatCode>General</c:formatCode>
                  <c:ptCount val="4"/>
                  <c:pt idx="0">
                    <c:v>1.504600943772135</c:v>
                  </c:pt>
                  <c:pt idx="1">
                    <c:v>2.3193158473998348</c:v>
                  </c:pt>
                  <c:pt idx="2">
                    <c:v>3.3404903831623298</c:v>
                  </c:pt>
                  <c:pt idx="3">
                    <c:v>3.8524688188225467</c:v>
                  </c:pt>
                </c:numCache>
              </c:numRef>
            </c:minus>
          </c:errBars>
          <c:cat>
            <c:strRef>
              <c:f>'Thymidine-8h'!$P$3:$P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'Thymidine-8h'!$Q$3:$Q$6</c:f>
              <c:numCache>
                <c:formatCode>General</c:formatCode>
                <c:ptCount val="4"/>
                <c:pt idx="0">
                  <c:v>19.785999999999969</c:v>
                </c:pt>
                <c:pt idx="1">
                  <c:v>27.72</c:v>
                </c:pt>
                <c:pt idx="2">
                  <c:v>28.133299999999988</c:v>
                </c:pt>
                <c:pt idx="3">
                  <c:v>42.379000000000005</c:v>
                </c:pt>
              </c:numCache>
            </c:numRef>
          </c:val>
        </c:ser>
        <c:ser>
          <c:idx val="1"/>
          <c:order val="1"/>
          <c:tx>
            <c:strRef>
              <c:f>'Thymidine-8h'!$R$2</c:f>
              <c:strCache>
                <c:ptCount val="1"/>
                <c:pt idx="0">
                  <c:v>S</c:v>
                </c:pt>
              </c:strCache>
            </c:strRef>
          </c:tx>
          <c:spPr>
            <a:blipFill>
              <a:blip xmlns:r="http://schemas.openxmlformats.org/officeDocument/2006/relationships" r:embed="rId1"/>
              <a:stretch>
                <a:fillRect/>
              </a:stretch>
            </a:blipFill>
            <a:ln>
              <a:solidFill>
                <a:prstClr val="white">
                  <a:lumMod val="50000"/>
                </a:prstClr>
              </a:solidFill>
            </a:ln>
          </c:spPr>
          <c:pictureOptions>
            <c:pictureFormat val="stack"/>
          </c:pictureOptions>
          <c:errBars>
            <c:errBarType val="both"/>
            <c:errValType val="cust"/>
            <c:plus>
              <c:numRef>
                <c:f>'Thymidine-8h'!$R$8:$R$11</c:f>
                <c:numCache>
                  <c:formatCode>General</c:formatCode>
                  <c:ptCount val="4"/>
                  <c:pt idx="0">
                    <c:v>3.418042714771127</c:v>
                  </c:pt>
                  <c:pt idx="1">
                    <c:v>2.2281481099783336</c:v>
                  </c:pt>
                  <c:pt idx="2">
                    <c:v>1.9113806528266484</c:v>
                  </c:pt>
                  <c:pt idx="3">
                    <c:v>0.7913886529386337</c:v>
                  </c:pt>
                </c:numCache>
              </c:numRef>
            </c:plus>
            <c:minus>
              <c:numRef>
                <c:f>'Thymidine-8h'!$R$8:$R$11</c:f>
                <c:numCache>
                  <c:formatCode>General</c:formatCode>
                  <c:ptCount val="4"/>
                  <c:pt idx="0">
                    <c:v>3.418042714771127</c:v>
                  </c:pt>
                  <c:pt idx="1">
                    <c:v>2.2281481099783336</c:v>
                  </c:pt>
                  <c:pt idx="2">
                    <c:v>1.9113806528266484</c:v>
                  </c:pt>
                  <c:pt idx="3">
                    <c:v>0.7913886529386337</c:v>
                  </c:pt>
                </c:numCache>
              </c:numRef>
            </c:minus>
          </c:errBars>
          <c:cat>
            <c:strRef>
              <c:f>'Thymidine-8h'!$P$3:$P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'Thymidine-8h'!$R$3:$R$6</c:f>
              <c:numCache>
                <c:formatCode>General</c:formatCode>
                <c:ptCount val="4"/>
                <c:pt idx="0">
                  <c:v>29.387999999999987</c:v>
                </c:pt>
                <c:pt idx="1">
                  <c:v>30.131999999999998</c:v>
                </c:pt>
                <c:pt idx="2">
                  <c:v>28.013299999999987</c:v>
                </c:pt>
                <c:pt idx="3">
                  <c:v>25.868999999999989</c:v>
                </c:pt>
              </c:numCache>
            </c:numRef>
          </c:val>
        </c:ser>
        <c:ser>
          <c:idx val="2"/>
          <c:order val="2"/>
          <c:tx>
            <c:strRef>
              <c:f>'Thymidine-8h'!$S$2</c:f>
              <c:strCache>
                <c:ptCount val="1"/>
                <c:pt idx="0">
                  <c:v>G2/M</c:v>
                </c:pt>
              </c:strCache>
            </c:strRef>
          </c:tx>
          <c:spPr>
            <a:blipFill>
              <a:blip xmlns:r="http://schemas.openxmlformats.org/officeDocument/2006/relationships" r:embed="rId2"/>
              <a:stretch>
                <a:fillRect/>
              </a:stretch>
            </a:blipFill>
          </c:spPr>
          <c:pictureOptions>
            <c:pictureFormat val="stack"/>
          </c:pictureOptions>
          <c:errBars>
            <c:errBarType val="both"/>
            <c:errValType val="cust"/>
            <c:plus>
              <c:numRef>
                <c:f>'Thymidine-8h'!$S$8:$S$11</c:f>
                <c:numCache>
                  <c:formatCode>General</c:formatCode>
                  <c:ptCount val="4"/>
                  <c:pt idx="0">
                    <c:v>0.73040673600409534</c:v>
                  </c:pt>
                  <c:pt idx="1">
                    <c:v>1.0204636201256418</c:v>
                  </c:pt>
                  <c:pt idx="2">
                    <c:v>1.1810190514974455</c:v>
                  </c:pt>
                  <c:pt idx="3">
                    <c:v>0.98713018391700236</c:v>
                  </c:pt>
                </c:numCache>
              </c:numRef>
            </c:plus>
            <c:minus>
              <c:numRef>
                <c:f>'Thymidine-8h'!$S$8:$S$11</c:f>
                <c:numCache>
                  <c:formatCode>General</c:formatCode>
                  <c:ptCount val="4"/>
                  <c:pt idx="0">
                    <c:v>0.73040673600409534</c:v>
                  </c:pt>
                  <c:pt idx="1">
                    <c:v>1.0204636201256418</c:v>
                  </c:pt>
                  <c:pt idx="2">
                    <c:v>1.1810190514974455</c:v>
                  </c:pt>
                  <c:pt idx="3">
                    <c:v>0.98713018391700236</c:v>
                  </c:pt>
                </c:numCache>
              </c:numRef>
            </c:minus>
          </c:errBars>
          <c:cat>
            <c:strRef>
              <c:f>'Thymidine-8h'!$P$3:$P$6</c:f>
              <c:strCache>
                <c:ptCount val="4"/>
                <c:pt idx="0">
                  <c:v>siTM</c:v>
                </c:pt>
                <c:pt idx="1">
                  <c:v>siTopBP1</c:v>
                </c:pt>
                <c:pt idx="2">
                  <c:v>siMYH</c:v>
                </c:pt>
                <c:pt idx="3">
                  <c:v>siGFP</c:v>
                </c:pt>
              </c:strCache>
            </c:strRef>
          </c:cat>
          <c:val>
            <c:numRef>
              <c:f>'Thymidine-8h'!$S$3:$S$6</c:f>
              <c:numCache>
                <c:formatCode>General</c:formatCode>
                <c:ptCount val="4"/>
                <c:pt idx="0">
                  <c:v>50.826000000000001</c:v>
                </c:pt>
                <c:pt idx="1">
                  <c:v>42.14800000000001</c:v>
                </c:pt>
                <c:pt idx="2">
                  <c:v>43.853300000000004</c:v>
                </c:pt>
                <c:pt idx="3">
                  <c:v>31.750999999999987</c:v>
                </c:pt>
              </c:numCache>
            </c:numRef>
          </c:val>
        </c:ser>
        <c:gapWidth val="55"/>
        <c:overlap val="100"/>
        <c:axId val="60369920"/>
        <c:axId val="60379904"/>
      </c:barChart>
      <c:catAx>
        <c:axId val="60369920"/>
        <c:scaling>
          <c:orientation val="minMax"/>
        </c:scaling>
        <c:axPos val="l"/>
        <c:tickLblPos val="nextTo"/>
        <c:txPr>
          <a:bodyPr/>
          <a:lstStyle/>
          <a:p>
            <a:pPr>
              <a:defRPr sz="1100" b="1"/>
            </a:pPr>
            <a:endParaRPr lang="ko-KR"/>
          </a:p>
        </c:txPr>
        <c:crossAx val="60379904"/>
        <c:crosses val="autoZero"/>
        <c:auto val="1"/>
        <c:lblAlgn val="ctr"/>
        <c:lblOffset val="100"/>
      </c:catAx>
      <c:valAx>
        <c:axId val="60379904"/>
        <c:scaling>
          <c:orientation val="minMax"/>
          <c:max val="110"/>
          <c:min val="0"/>
        </c:scaling>
        <c:axPos val="b"/>
        <c:majorGridlines/>
        <c:numFmt formatCode="General" sourceLinked="1"/>
        <c:tickLblPos val="nextTo"/>
        <c:crossAx val="603699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8013055555555542"/>
          <c:y val="0.3986377005445233"/>
          <c:w val="0.11986944444444446"/>
          <c:h val="0.35941198994629964"/>
        </c:manualLayout>
      </c:layout>
    </c:legend>
    <c:plotVisOnly val="1"/>
  </c:chart>
  <c:externalData r:id="rId3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355672-ADA1-4EA7-A63D-987FA2012D23}" type="datetimeFigureOut">
              <a:rPr lang="ko-KR" altLang="en-US" smtClean="0"/>
              <a:pPr/>
              <a:t>2015-04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7B366-B1A1-454B-BBA5-427A1DD77E9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jpe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8"/>
          <p:cNvGrpSpPr/>
          <p:nvPr/>
        </p:nvGrpSpPr>
        <p:grpSpPr>
          <a:xfrm>
            <a:off x="107504" y="44624"/>
            <a:ext cx="8712968" cy="6192688"/>
            <a:chOff x="107504" y="548680"/>
            <a:chExt cx="8712968" cy="6192688"/>
          </a:xfrm>
        </p:grpSpPr>
        <p:grpSp>
          <p:nvGrpSpPr>
            <p:cNvPr id="4" name="그룹 52"/>
            <p:cNvGrpSpPr/>
            <p:nvPr/>
          </p:nvGrpSpPr>
          <p:grpSpPr>
            <a:xfrm>
              <a:off x="107504" y="648072"/>
              <a:ext cx="4320000" cy="6093296"/>
              <a:chOff x="323528" y="548680"/>
              <a:chExt cx="4320000" cy="6093296"/>
            </a:xfrm>
          </p:grpSpPr>
          <p:graphicFrame>
            <p:nvGraphicFramePr>
              <p:cNvPr id="49" name="차트 48"/>
              <p:cNvGraphicFramePr/>
              <p:nvPr/>
            </p:nvGraphicFramePr>
            <p:xfrm>
              <a:off x="323528" y="548680"/>
              <a:ext cx="4320000" cy="191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0" name="차트 49"/>
              <p:cNvGraphicFramePr/>
              <p:nvPr/>
            </p:nvGraphicFramePr>
            <p:xfrm>
              <a:off x="323528" y="2636912"/>
              <a:ext cx="4320000" cy="191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51" name="차트 50"/>
              <p:cNvGraphicFramePr/>
              <p:nvPr/>
            </p:nvGraphicFramePr>
            <p:xfrm>
              <a:off x="323528" y="4725070"/>
              <a:ext cx="4320000" cy="191690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  <p:pic>
          <p:nvPicPr>
            <p:cNvPr id="8" name="그림 7" descr="그림2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492877" y="548680"/>
              <a:ext cx="4327595" cy="4708197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4572000" y="4811668"/>
            <a:ext cx="4248472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Additional file 1. Knockdown of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hMYH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and hTopBP1 affects to cell cycle progression. HEK293 cells were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transfected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with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iGFP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,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iMYH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, siTopBP1, or both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iMYH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and siTopBP1. Then untreated or treated 20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mM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HU for 1 h. 3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mM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Thymidine</a:t>
            </a:r>
            <a:r>
              <a:rPr lang="en-US" altLang="ko-KR" sz="10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was treated to arresting cell cycle in S phase. After 18 h, cells were harvested or incubated in fresh media for 8 h to release </a:t>
            </a:r>
            <a:r>
              <a:rPr lang="en-US" altLang="ko-KR" sz="1000" dirty="0" err="1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thymidine</a:t>
            </a:r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.</a:t>
            </a:r>
          </a:p>
          <a:p>
            <a:pPr algn="just"/>
            <a:endParaRPr lang="en-US" altLang="ko-KR" sz="1000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just" latinLnBrk="0"/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Knockdown of </a:t>
            </a:r>
            <a:r>
              <a:rPr lang="en-US" altLang="ko-KR" sz="1000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hMYH</a:t>
            </a:r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and hTopBP1 diminished the DNA damage recovery and cell cycle progress in contrast of control using </a:t>
            </a:r>
            <a:r>
              <a:rPr lang="en-US" altLang="ko-KR" sz="1000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iGFP</a:t>
            </a:r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. </a:t>
            </a:r>
            <a:endParaRPr lang="ko-KR" altLang="ko-KR" sz="1000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just" latinLnBrk="0"/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 </a:t>
            </a:r>
            <a:endParaRPr lang="ko-KR" altLang="ko-KR" sz="1000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just" latinLnBrk="0"/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This result shown that knockdown of </a:t>
            </a:r>
            <a:r>
              <a:rPr lang="en-US" altLang="ko-KR" sz="1000" dirty="0" err="1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hMYH</a:t>
            </a:r>
            <a:r>
              <a:rPr lang="en-US" altLang="ko-KR" sz="10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 and hTopBP1 induced cell cycle arrest delay.</a:t>
            </a:r>
            <a:endParaRPr lang="ko-KR" altLang="ko-KR" sz="1000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just"/>
            <a:endParaRPr lang="ko-KR" altLang="ko-KR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  <a:p>
            <a:pPr algn="just"/>
            <a:endParaRPr lang="ko-KR" altLang="en-US" sz="10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05</Words>
  <Application>Microsoft Office PowerPoint</Application>
  <PresentationFormat>화면 슬라이드 쇼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1</dc:title>
  <dc:creator>Administrator</dc:creator>
  <cp:lastModifiedBy>Administrator</cp:lastModifiedBy>
  <cp:revision>3</cp:revision>
  <dcterms:created xsi:type="dcterms:W3CDTF">2015-04-09T00:55:27Z</dcterms:created>
  <dcterms:modified xsi:type="dcterms:W3CDTF">2015-04-10T07:45:34Z</dcterms:modified>
</cp:coreProperties>
</file>